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2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EECD5B-AF5E-5DF2-26D0-4534944002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E4D1BB-E25E-58F9-6954-BE3CFD33C5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76DB48-9B9E-D60E-6A29-F562283DB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A306E-B19F-53BD-40D2-D644E15B6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2FB514-9178-D5B0-9A0A-DB6CDBCD9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010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A134E-93E2-4508-6705-6041EDB1A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EAD099-279A-0772-9CEE-39FECDD844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EEFAE-3B7F-DA7C-047F-DB63723FD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BC2047-5808-34C5-2466-EC1DE7425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053C3-8836-ED2A-A832-25B405539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983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76A8C7-DF91-030D-C8BC-DD5DF3981D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0C8406-C811-7D9A-4DDB-E9AE9B90F9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7A5DE3-40D5-F3C0-F805-5046BE6F4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E8445A-C3FB-D1B9-D43F-C7FD33FE5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FD4E78-BD0F-33DD-E03C-CBB64561C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183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FE44F-93B0-8611-C821-EE4F416D2F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66F28B-2247-C626-4702-34C12A4B98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CF959-572F-8A47-DB26-0E4477DC8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EADA1-34FE-BFF6-A337-C04418765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915662-45A2-280D-3174-0CAC91F55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41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754E4-5D21-85A5-C902-C14F21571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BEC779-83C4-1D21-1B2A-F4005C4BF5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284C36-065E-0421-9153-F0A6CD9CD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F54070-7916-9B02-1A60-CE5B06799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DEA91-F3FC-9825-9DD2-A02C4BE50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7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84EC6-F9CA-C68B-A233-B1A934332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A3C330-E187-8772-F9EA-25DBD905E2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0A08DF-980C-912F-D191-8F54CAA69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D52577-5475-4E4D-93A7-C802CCA88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9F2C25-EB65-DAA1-F99A-68AE8EA8D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C5C6E7-26D6-D6D1-3363-FE8160312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21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9C645C-54CE-7825-9C6B-F4A528051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0AC696-FDC7-E048-6A89-6C0AD870F4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EE2800-1412-475A-B22B-840B435E6D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BB2C29-4D40-7810-8640-E80FBFA807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BA1DE9-F960-8CAE-35C6-7F87AD1FFE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1F44A2-78EA-E232-2800-F297B00BA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671AFD-6D32-6B36-D163-CEECA852A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D73C4B0-DE1B-2B8E-F179-09CA7B151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2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C3EEC-ED86-AAC9-A06D-4ECB5FE7F3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18C4C2-65E8-D4E7-8AC7-1E84DB75E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EF8FC5-9F52-5DF7-3AF1-1768BE3ED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6980C83-A226-A889-7FAA-309BEB311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978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32CCE9-A5C9-9D00-AEDE-410761C33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7A4F1D-950A-378E-751F-101EA8FBB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2A258D-42F1-7DAE-5DB7-E69CA37A2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319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32D96-32DD-C147-1284-31A02E5FD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B76F05-A7F1-6C35-7459-794DB1700A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B73B22-8795-4A06-31AE-78900FF61A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003D52-E60B-095C-B810-FEAA04419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FC7A53-7055-0CA0-A2CE-20C9A1EB62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D9B08EB-C632-E814-B971-7E039B37F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196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FBB1A-5B1F-7595-3F56-07003EF137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4977CC-951B-060C-9B28-83236A488F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D68FE6-0EB8-5FF5-5920-2BA86484CA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ED2434-8E9A-D2D5-9A23-5B98D4E7A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5B236B-8A72-AB54-8228-90F540963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3F7081-21BF-C603-3022-F04737B07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268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024181-6F8D-2E6B-E83B-56B6A1095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6206D2-4BED-9084-6B0B-5CCCD1678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501172-9F80-5E8C-D0E6-C086C8B0DA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32830-A7D0-48AC-8719-1E74966C40B6}" type="datetimeFigureOut">
              <a:rPr lang="en-US" smtClean="0"/>
              <a:t>3/2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47E5A5-87BD-6432-6325-CB76C00B42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EA5238-1F73-7B40-5208-4EFED86BE5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1E44E5-3056-4F3B-95FD-A5EF2AE4C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716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99257C2F-3C96-D91D-0B34-F82A34B14F2D}"/>
              </a:ext>
            </a:extLst>
          </p:cNvPr>
          <p:cNvGrpSpPr/>
          <p:nvPr/>
        </p:nvGrpSpPr>
        <p:grpSpPr>
          <a:xfrm>
            <a:off x="434108" y="1851457"/>
            <a:ext cx="5165461" cy="2892753"/>
            <a:chOff x="2309092" y="1491239"/>
            <a:chExt cx="5165461" cy="2892753"/>
          </a:xfrm>
        </p:grpSpPr>
        <p:pic>
          <p:nvPicPr>
            <p:cNvPr id="5" name="Picture 4" descr="Graphical user interface&#10;&#10;Description automatically generated">
              <a:extLst>
                <a:ext uri="{FF2B5EF4-FFF2-40B4-BE49-F238E27FC236}">
                  <a16:creationId xmlns:a16="http://schemas.microsoft.com/office/drawing/2014/main" id="{9266BA09-3355-AFD6-C45E-DFB62DADEFB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80874" y="1860571"/>
              <a:ext cx="3419788" cy="2154089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5C67887-4559-9712-D04D-4D6878CC16CB}"/>
                </a:ext>
              </a:extLst>
            </p:cNvPr>
            <p:cNvSpPr txBox="1"/>
            <p:nvPr/>
          </p:nvSpPr>
          <p:spPr>
            <a:xfrm>
              <a:off x="2484583" y="2142836"/>
              <a:ext cx="14962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k2_80kD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A0CB54C-0953-EEAC-60D2-B21381FEE34D}"/>
                </a:ext>
              </a:extLst>
            </p:cNvPr>
            <p:cNvSpPr txBox="1"/>
            <p:nvPr/>
          </p:nvSpPr>
          <p:spPr>
            <a:xfrm>
              <a:off x="2309092" y="3078748"/>
              <a:ext cx="17595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pERK_42/44kD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B80B016-FDC4-84C3-1B41-BCC59010B6E0}"/>
                </a:ext>
              </a:extLst>
            </p:cNvPr>
            <p:cNvSpPr txBox="1"/>
            <p:nvPr/>
          </p:nvSpPr>
          <p:spPr>
            <a:xfrm>
              <a:off x="5904371" y="1491239"/>
              <a:ext cx="14962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+ 1uM S1P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819EA95-90CE-0F40-D60B-A94BA5FC42CA}"/>
                </a:ext>
              </a:extLst>
            </p:cNvPr>
            <p:cNvSpPr txBox="1"/>
            <p:nvPr/>
          </p:nvSpPr>
          <p:spPr>
            <a:xfrm>
              <a:off x="4194477" y="1491239"/>
              <a:ext cx="14962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- 1uM S1P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F532791-B314-C031-DFB8-D7924CA9ED08}"/>
                </a:ext>
              </a:extLst>
            </p:cNvPr>
            <p:cNvSpPr txBox="1"/>
            <p:nvPr/>
          </p:nvSpPr>
          <p:spPr>
            <a:xfrm>
              <a:off x="3980874" y="4014660"/>
              <a:ext cx="535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T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6E39C5E-9A74-AC61-B999-1569E40C9FA0}"/>
                </a:ext>
              </a:extLst>
            </p:cNvPr>
            <p:cNvSpPr txBox="1"/>
            <p:nvPr/>
          </p:nvSpPr>
          <p:spPr>
            <a:xfrm>
              <a:off x="4424218" y="4014660"/>
              <a:ext cx="822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1PR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F63A3C9-C401-E528-255D-8B6FAA89426E}"/>
                </a:ext>
              </a:extLst>
            </p:cNvPr>
            <p:cNvSpPr txBox="1"/>
            <p:nvPr/>
          </p:nvSpPr>
          <p:spPr>
            <a:xfrm>
              <a:off x="5090403" y="4014660"/>
              <a:ext cx="822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K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EDB6FFF-2F54-A450-3D40-7E5721ABB92D}"/>
                </a:ext>
              </a:extLst>
            </p:cNvPr>
            <p:cNvSpPr txBox="1"/>
            <p:nvPr/>
          </p:nvSpPr>
          <p:spPr>
            <a:xfrm>
              <a:off x="6652516" y="4014660"/>
              <a:ext cx="822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K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40F8615-E486-74CD-A08F-41782FDB0B00}"/>
                </a:ext>
              </a:extLst>
            </p:cNvPr>
            <p:cNvSpPr txBox="1"/>
            <p:nvPr/>
          </p:nvSpPr>
          <p:spPr>
            <a:xfrm>
              <a:off x="6075242" y="4014660"/>
              <a:ext cx="82203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1PR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45509F8-AFC1-17A1-9321-04B4A42ABCE5}"/>
                </a:ext>
              </a:extLst>
            </p:cNvPr>
            <p:cNvSpPr txBox="1"/>
            <p:nvPr/>
          </p:nvSpPr>
          <p:spPr>
            <a:xfrm>
              <a:off x="5733497" y="4014660"/>
              <a:ext cx="5357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T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093C267F-511E-517A-B4D8-82D0F78263D5}"/>
              </a:ext>
            </a:extLst>
          </p:cNvPr>
          <p:cNvSpPr txBox="1"/>
          <p:nvPr/>
        </p:nvSpPr>
        <p:spPr>
          <a:xfrm>
            <a:off x="434108" y="378691"/>
            <a:ext cx="110466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mple 511 – data in X:\pro_CRISPR\Rat MBP T cells migration project\</a:t>
            </a:r>
            <a:r>
              <a:rPr lang="en-US" dirty="0" err="1"/>
              <a:t>WesternBlot</a:t>
            </a:r>
            <a:r>
              <a:rPr lang="en-US" dirty="0"/>
              <a:t>\BCA measure\2023.03.12 </a:t>
            </a:r>
            <a:r>
              <a:rPr lang="en-US" dirty="0" err="1"/>
              <a:t>HumanT</a:t>
            </a:r>
            <a:r>
              <a:rPr lang="en-US" dirty="0"/>
              <a:t> cells NT and Grk2 UnS_10min</a:t>
            </a:r>
          </a:p>
        </p:txBody>
      </p:sp>
      <p:pic>
        <p:nvPicPr>
          <p:cNvPr id="19" name="Picture 18" descr="A picture containing tableware&#10;&#10;Description automatically generated">
            <a:extLst>
              <a:ext uri="{FF2B5EF4-FFF2-40B4-BE49-F238E27FC236}">
                <a16:creationId xmlns:a16="http://schemas.microsoft.com/office/drawing/2014/main" id="{2A12E2F0-0109-2A18-B6B9-62370618BF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3728" y="2503054"/>
            <a:ext cx="3908643" cy="135118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F9B53B45-58A1-ED80-9DCF-11F7FD2FCED8}"/>
              </a:ext>
            </a:extLst>
          </p:cNvPr>
          <p:cNvSpPr txBox="1"/>
          <p:nvPr/>
        </p:nvSpPr>
        <p:spPr>
          <a:xfrm>
            <a:off x="5786560" y="2891432"/>
            <a:ext cx="1759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ERK_42/44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0281881-67E3-FBC6-60C4-8FD9DB37002C}"/>
              </a:ext>
            </a:extLst>
          </p:cNvPr>
          <p:cNvSpPr txBox="1"/>
          <p:nvPr/>
        </p:nvSpPr>
        <p:spPr>
          <a:xfrm>
            <a:off x="8031018" y="3808298"/>
            <a:ext cx="535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7B18EF-02AF-AD8B-0466-958E414146DC}"/>
              </a:ext>
            </a:extLst>
          </p:cNvPr>
          <p:cNvSpPr txBox="1"/>
          <p:nvPr/>
        </p:nvSpPr>
        <p:spPr>
          <a:xfrm>
            <a:off x="8474362" y="3808298"/>
            <a:ext cx="82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PR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81E275-70CE-EB18-B961-3D0535A53165}"/>
              </a:ext>
            </a:extLst>
          </p:cNvPr>
          <p:cNvSpPr txBox="1"/>
          <p:nvPr/>
        </p:nvSpPr>
        <p:spPr>
          <a:xfrm>
            <a:off x="9140547" y="3808298"/>
            <a:ext cx="82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RK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393C3B-4AEE-B788-83D4-20B1D24684BB}"/>
              </a:ext>
            </a:extLst>
          </p:cNvPr>
          <p:cNvSpPr txBox="1"/>
          <p:nvPr/>
        </p:nvSpPr>
        <p:spPr>
          <a:xfrm>
            <a:off x="10702660" y="3808298"/>
            <a:ext cx="82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RK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022977-A427-7958-EC81-A9478EC3BB4E}"/>
              </a:ext>
            </a:extLst>
          </p:cNvPr>
          <p:cNvSpPr txBox="1"/>
          <p:nvPr/>
        </p:nvSpPr>
        <p:spPr>
          <a:xfrm>
            <a:off x="10125386" y="3808298"/>
            <a:ext cx="822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PR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3F2D4C5-6F7F-367C-BE3D-4F06BC531A5D}"/>
              </a:ext>
            </a:extLst>
          </p:cNvPr>
          <p:cNvSpPr txBox="1"/>
          <p:nvPr/>
        </p:nvSpPr>
        <p:spPr>
          <a:xfrm>
            <a:off x="9783641" y="3808298"/>
            <a:ext cx="535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T</a:t>
            </a:r>
          </a:p>
        </p:txBody>
      </p:sp>
    </p:spTree>
    <p:extLst>
      <p:ext uri="{BB962C8B-B14F-4D97-AF65-F5344CB8AC3E}">
        <p14:creationId xmlns:p14="http://schemas.microsoft.com/office/powerpoint/2010/main" val="266158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k Kendirli</dc:creator>
  <cp:lastModifiedBy>Arek Kendirli</cp:lastModifiedBy>
  <cp:revision>5</cp:revision>
  <dcterms:created xsi:type="dcterms:W3CDTF">2023-03-23T17:37:00Z</dcterms:created>
  <dcterms:modified xsi:type="dcterms:W3CDTF">2023-03-23T17:58:56Z</dcterms:modified>
</cp:coreProperties>
</file>